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5A386A-220E-4924-AE03-F91C67323273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7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2 Changes in the expression of genes in sucrose and fermentation pathways of </a:t>
            </a:r>
            <a:r>
              <a:rPr b="0" i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i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achalinensis</a:t>
            </a: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under waterlogging stress. Green indicates the down-regulated gene expression, while red indicates the up-regulated gene expression.</a:t>
            </a:r>
            <a:br>
              <a:rPr sz="2000"/>
            </a:b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C4F1EE-0178-4F88-8493-2CE99AB9C061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27A63-AD0E-4C5E-984D-5352647655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51499A-1707-48CE-AB4C-10AFAC9DEE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7A3415-3A4E-4D5F-BD52-CF1F04CFC3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06FF2-3832-44C7-99EA-58C4AF8A00D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BE50BE-E338-4901-826F-2B748ECD64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024A41-5C26-4DC8-AC09-6CA4D43A15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D67089-BCD8-4AF8-9750-6C658552FE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2DF6E-C7BD-40A8-9951-7030B4A100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4AF46-EE70-4B5E-9332-DD5DB4EF99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19E7C-AD9D-4033-B68C-B55709865C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8DF4F5-44ED-4ACE-84B4-823DA90FDA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818CB-7848-48BB-A6D2-B329F30B01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0E113A-8717-4C37-8369-B0A031FA797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"/>
          <p:cNvSpPr/>
          <p:nvPr/>
        </p:nvSpPr>
        <p:spPr>
          <a:xfrm>
            <a:off x="1689120" y="1300320"/>
            <a:ext cx="7477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cro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5"/>
          <p:cNvSpPr/>
          <p:nvPr/>
        </p:nvSpPr>
        <p:spPr>
          <a:xfrm>
            <a:off x="5218560" y="3213000"/>
            <a:ext cx="179604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osphoenol-pyruvat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61"/>
          <p:cNvSpPr/>
          <p:nvPr/>
        </p:nvSpPr>
        <p:spPr>
          <a:xfrm>
            <a:off x="5776560" y="4348080"/>
            <a:ext cx="8179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yruvat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65"/>
          <p:cNvSpPr/>
          <p:nvPr/>
        </p:nvSpPr>
        <p:spPr>
          <a:xfrm>
            <a:off x="8219880" y="4351320"/>
            <a:ext cx="8161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-lactat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68"/>
          <p:cNvSpPr/>
          <p:nvPr/>
        </p:nvSpPr>
        <p:spPr>
          <a:xfrm>
            <a:off x="5603040" y="5637240"/>
            <a:ext cx="11653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etaldehyd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72"/>
          <p:cNvSpPr/>
          <p:nvPr/>
        </p:nvSpPr>
        <p:spPr>
          <a:xfrm>
            <a:off x="8258760" y="5637240"/>
            <a:ext cx="73836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thano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77"/>
          <p:cNvSpPr/>
          <p:nvPr/>
        </p:nvSpPr>
        <p:spPr>
          <a:xfrm>
            <a:off x="3438720" y="5637240"/>
            <a:ext cx="72648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etat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78"/>
          <p:cNvSpPr/>
          <p:nvPr/>
        </p:nvSpPr>
        <p:spPr>
          <a:xfrm>
            <a:off x="2889360" y="4348080"/>
            <a:ext cx="187164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-Hydroxy-ethyl-ThP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6" name="直接箭头连接符 99"/>
          <p:cNvCxnSpPr>
            <a:stCxn id="50" idx="1"/>
            <a:endCxn id="55" idx="3"/>
          </p:cNvCxnSpPr>
          <p:nvPr/>
        </p:nvCxnSpPr>
        <p:spPr>
          <a:xfrm flipH="1">
            <a:off x="4761000" y="4501440"/>
            <a:ext cx="101592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7" name="弧形 101"/>
          <p:cNvSpPr/>
          <p:nvPr/>
        </p:nvSpPr>
        <p:spPr>
          <a:xfrm>
            <a:off x="4307040" y="3762360"/>
            <a:ext cx="726840" cy="743040"/>
          </a:xfrm>
          <a:custGeom>
            <a:avLst/>
            <a:gdLst/>
            <a:ahLst/>
            <a:rect l="l" t="t" r="r" b="b"/>
            <a:pathLst>
              <a:path stroke="0" w="727033" h="742275">
                <a:moveTo>
                  <a:pt x="363516" y="0"/>
                </a:moveTo>
                <a:cubicBezTo>
                  <a:pt x="542836" y="0"/>
                  <a:pt x="695367" y="133503"/>
                  <a:pt x="722765" y="314433"/>
                </a:cubicBezTo>
                <a:cubicBezTo>
                  <a:pt x="749901" y="493633"/>
                  <a:pt x="646235" y="666616"/>
                  <a:pt x="477603" y="723525"/>
                </a:cubicBezTo>
                <a:lnTo>
                  <a:pt x="363517" y="371138"/>
                </a:lnTo>
                <a:cubicBezTo>
                  <a:pt x="363517" y="247425"/>
                  <a:pt x="363516" y="123713"/>
                  <a:pt x="363516" y="0"/>
                </a:cubicBezTo>
                <a:close/>
              </a:path>
              <a:path fill="none" w="727033" h="742275">
                <a:moveTo>
                  <a:pt x="363516" y="0"/>
                </a:moveTo>
                <a:cubicBezTo>
                  <a:pt x="542836" y="0"/>
                  <a:pt x="695367" y="133503"/>
                  <a:pt x="722765" y="314433"/>
                </a:cubicBezTo>
                <a:cubicBezTo>
                  <a:pt x="749901" y="493633"/>
                  <a:pt x="646235" y="666616"/>
                  <a:pt x="477603" y="723525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04"/>
          <p:cNvSpPr/>
          <p:nvPr/>
        </p:nvSpPr>
        <p:spPr>
          <a:xfrm>
            <a:off x="3534840" y="3614760"/>
            <a:ext cx="57708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P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9" name="直接箭头连接符 109"/>
          <p:cNvCxnSpPr/>
          <p:nvPr/>
        </p:nvCxnSpPr>
        <p:spPr>
          <a:xfrm>
            <a:off x="6162480" y="4655880"/>
            <a:ext cx="1080" cy="981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0" name="直接箭头连接符 114"/>
          <p:cNvCxnSpPr>
            <a:stCxn id="55" idx="1"/>
          </p:cNvCxnSpPr>
          <p:nvPr/>
        </p:nvCxnSpPr>
        <p:spPr>
          <a:xfrm flipH="1">
            <a:off x="1936440" y="4501440"/>
            <a:ext cx="953280" cy="1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1" name="TextBox 117"/>
          <p:cNvSpPr/>
          <p:nvPr/>
        </p:nvSpPr>
        <p:spPr>
          <a:xfrm>
            <a:off x="250920" y="4221000"/>
            <a:ext cx="165708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-acetyl-dihydrolipoamide-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弧形 119"/>
          <p:cNvSpPr/>
          <p:nvPr/>
        </p:nvSpPr>
        <p:spPr>
          <a:xfrm flipH="1">
            <a:off x="2657520" y="3767040"/>
            <a:ext cx="558720" cy="735120"/>
          </a:xfrm>
          <a:custGeom>
            <a:avLst/>
            <a:gdLst/>
            <a:ahLst/>
            <a:rect l="l" t="t" r="r" b="b"/>
            <a:pathLst>
              <a:path stroke="0" w="559600" h="735597">
                <a:moveTo>
                  <a:pt x="279800" y="0"/>
                </a:moveTo>
                <a:cubicBezTo>
                  <a:pt x="421427" y="0"/>
                  <a:pt x="540719" y="139108"/>
                  <a:pt x="557604" y="323949"/>
                </a:cubicBezTo>
                <a:cubicBezTo>
                  <a:pt x="572442" y="486377"/>
                  <a:pt x="503881" y="642163"/>
                  <a:pt x="389367" y="706225"/>
                </a:cubicBezTo>
                <a:lnTo>
                  <a:pt x="279800" y="367799"/>
                </a:lnTo>
                <a:lnTo>
                  <a:pt x="279800" y="0"/>
                </a:lnTo>
                <a:close/>
              </a:path>
              <a:path fill="none" w="559600" h="735597">
                <a:moveTo>
                  <a:pt x="279800" y="0"/>
                </a:moveTo>
                <a:cubicBezTo>
                  <a:pt x="421427" y="0"/>
                  <a:pt x="540719" y="139108"/>
                  <a:pt x="557604" y="323949"/>
                </a:cubicBezTo>
                <a:cubicBezTo>
                  <a:pt x="572442" y="486377"/>
                  <a:pt x="503881" y="642163"/>
                  <a:pt x="389367" y="706225"/>
                </a:cubicBez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3" name="直接箭头连接符 121"/>
          <p:cNvCxnSpPr/>
          <p:nvPr/>
        </p:nvCxnSpPr>
        <p:spPr>
          <a:xfrm>
            <a:off x="2911320" y="3768480"/>
            <a:ext cx="61056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4" name="TextBox 127"/>
          <p:cNvSpPr/>
          <p:nvPr/>
        </p:nvSpPr>
        <p:spPr>
          <a:xfrm>
            <a:off x="552240" y="5521320"/>
            <a:ext cx="105408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etyl-Co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5" name="直接箭头连接符 132"/>
          <p:cNvCxnSpPr>
            <a:stCxn id="50" idx="3"/>
            <a:endCxn id="51" idx="1"/>
          </p:cNvCxnSpPr>
          <p:nvPr/>
        </p:nvCxnSpPr>
        <p:spPr>
          <a:xfrm>
            <a:off x="6594480" y="4501440"/>
            <a:ext cx="1625760" cy="3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6" name="TextBox 6"/>
          <p:cNvSpPr/>
          <p:nvPr/>
        </p:nvSpPr>
        <p:spPr>
          <a:xfrm>
            <a:off x="5393160" y="74520"/>
            <a:ext cx="141516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-D-Glucose-1-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9"/>
          <p:cNvSpPr/>
          <p:nvPr/>
        </p:nvSpPr>
        <p:spPr>
          <a:xfrm>
            <a:off x="5393160" y="673200"/>
            <a:ext cx="141516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-D-Glucose-6-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8" name="直接箭头连接符 147"/>
          <p:cNvCxnSpPr/>
          <p:nvPr/>
        </p:nvCxnSpPr>
        <p:spPr>
          <a:xfrm>
            <a:off x="6162480" y="382320"/>
            <a:ext cx="1080" cy="291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69" name="组合 157"/>
          <p:cNvGrpSpPr/>
          <p:nvPr/>
        </p:nvGrpSpPr>
        <p:grpSpPr>
          <a:xfrm>
            <a:off x="6210360" y="455760"/>
            <a:ext cx="1092240" cy="106200"/>
            <a:chOff x="6210360" y="455760"/>
            <a:chExt cx="1092240" cy="106200"/>
          </a:xfrm>
        </p:grpSpPr>
        <p:sp>
          <p:nvSpPr>
            <p:cNvPr id="70" name="矩形 148"/>
            <p:cNvSpPr/>
            <p:nvPr/>
          </p:nvSpPr>
          <p:spPr>
            <a:xfrm>
              <a:off x="6329160" y="455760"/>
              <a:ext cx="100440" cy="10620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矩形 149"/>
            <p:cNvSpPr/>
            <p:nvPr/>
          </p:nvSpPr>
          <p:spPr>
            <a:xfrm>
              <a:off x="6458040" y="455760"/>
              <a:ext cx="100440" cy="10620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矩形 150"/>
            <p:cNvSpPr/>
            <p:nvPr/>
          </p:nvSpPr>
          <p:spPr>
            <a:xfrm>
              <a:off x="6573600" y="455760"/>
              <a:ext cx="100440" cy="10620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矩形 151"/>
            <p:cNvSpPr/>
            <p:nvPr/>
          </p:nvSpPr>
          <p:spPr>
            <a:xfrm>
              <a:off x="6689160" y="455760"/>
              <a:ext cx="100440" cy="10620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矩形 152"/>
            <p:cNvSpPr/>
            <p:nvPr/>
          </p:nvSpPr>
          <p:spPr>
            <a:xfrm>
              <a:off x="6210360" y="455760"/>
              <a:ext cx="100440" cy="10620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矩形 153"/>
            <p:cNvSpPr/>
            <p:nvPr/>
          </p:nvSpPr>
          <p:spPr>
            <a:xfrm>
              <a:off x="6809400" y="455760"/>
              <a:ext cx="100440" cy="10620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矩形 154"/>
            <p:cNvSpPr/>
            <p:nvPr/>
          </p:nvSpPr>
          <p:spPr>
            <a:xfrm>
              <a:off x="6933960" y="455760"/>
              <a:ext cx="100440" cy="10620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矩形 155"/>
            <p:cNvSpPr/>
            <p:nvPr/>
          </p:nvSpPr>
          <p:spPr>
            <a:xfrm>
              <a:off x="7065720" y="455760"/>
              <a:ext cx="100440" cy="10620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矩形 156"/>
            <p:cNvSpPr/>
            <p:nvPr/>
          </p:nvSpPr>
          <p:spPr>
            <a:xfrm>
              <a:off x="7202160" y="455760"/>
              <a:ext cx="100440" cy="10620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79" name="直接箭头连接符 162"/>
          <p:cNvCxnSpPr>
            <a:stCxn id="52" idx="3"/>
            <a:endCxn id="53" idx="1"/>
          </p:cNvCxnSpPr>
          <p:nvPr/>
        </p:nvCxnSpPr>
        <p:spPr>
          <a:xfrm>
            <a:off x="6768360" y="5790600"/>
            <a:ext cx="149076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0" name="矩形 164"/>
          <p:cNvSpPr/>
          <p:nvPr/>
        </p:nvSpPr>
        <p:spPr>
          <a:xfrm>
            <a:off x="7682040" y="5886360"/>
            <a:ext cx="101520" cy="108000"/>
          </a:xfrm>
          <a:prstGeom prst="rect">
            <a:avLst/>
          </a:prstGeom>
          <a:solidFill>
            <a:srgbClr val="ff0000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矩形 165"/>
          <p:cNvSpPr/>
          <p:nvPr/>
        </p:nvSpPr>
        <p:spPr>
          <a:xfrm>
            <a:off x="7869240" y="5886360"/>
            <a:ext cx="100080" cy="108000"/>
          </a:xfrm>
          <a:prstGeom prst="rect">
            <a:avLst/>
          </a:prstGeom>
          <a:solidFill>
            <a:srgbClr val="009900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2" name="组合 182"/>
          <p:cNvGrpSpPr/>
          <p:nvPr/>
        </p:nvGrpSpPr>
        <p:grpSpPr>
          <a:xfrm>
            <a:off x="6281640" y="4733640"/>
            <a:ext cx="457200" cy="795240"/>
            <a:chOff x="6281640" y="4733640"/>
            <a:chExt cx="457200" cy="795240"/>
          </a:xfrm>
        </p:grpSpPr>
        <p:sp>
          <p:nvSpPr>
            <p:cNvPr id="83" name="矩形 158"/>
            <p:cNvSpPr/>
            <p:nvPr/>
          </p:nvSpPr>
          <p:spPr>
            <a:xfrm rot="16200000">
              <a:off x="6635160" y="5159880"/>
              <a:ext cx="100440" cy="10692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矩形 159"/>
            <p:cNvSpPr/>
            <p:nvPr/>
          </p:nvSpPr>
          <p:spPr>
            <a:xfrm rot="16200000">
              <a:off x="6635160" y="5027040"/>
              <a:ext cx="100440" cy="10692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矩形 160"/>
            <p:cNvSpPr/>
            <p:nvPr/>
          </p:nvSpPr>
          <p:spPr>
            <a:xfrm rot="16200000">
              <a:off x="6635160" y="4894560"/>
              <a:ext cx="100440" cy="10692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矩形 167"/>
            <p:cNvSpPr/>
            <p:nvPr/>
          </p:nvSpPr>
          <p:spPr>
            <a:xfrm rot="16200000">
              <a:off x="6284880" y="542232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矩形 168"/>
            <p:cNvSpPr/>
            <p:nvPr/>
          </p:nvSpPr>
          <p:spPr>
            <a:xfrm rot="16200000">
              <a:off x="6284880" y="528444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矩形 169"/>
            <p:cNvSpPr/>
            <p:nvPr/>
          </p:nvSpPr>
          <p:spPr>
            <a:xfrm rot="16200000">
              <a:off x="6284880" y="514620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矩形 170"/>
            <p:cNvSpPr/>
            <p:nvPr/>
          </p:nvSpPr>
          <p:spPr>
            <a:xfrm rot="16200000">
              <a:off x="6284880" y="500832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矩形 171"/>
            <p:cNvSpPr/>
            <p:nvPr/>
          </p:nvSpPr>
          <p:spPr>
            <a:xfrm rot="16200000">
              <a:off x="6284880" y="48704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矩形 172"/>
            <p:cNvSpPr/>
            <p:nvPr/>
          </p:nvSpPr>
          <p:spPr>
            <a:xfrm rot="16200000">
              <a:off x="6284880" y="473220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矩形 173"/>
            <p:cNvSpPr/>
            <p:nvPr/>
          </p:nvSpPr>
          <p:spPr>
            <a:xfrm rot="16200000">
              <a:off x="6456960" y="54248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矩形 174"/>
            <p:cNvSpPr/>
            <p:nvPr/>
          </p:nvSpPr>
          <p:spPr>
            <a:xfrm rot="16200000">
              <a:off x="6456960" y="52862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矩形 175"/>
            <p:cNvSpPr/>
            <p:nvPr/>
          </p:nvSpPr>
          <p:spPr>
            <a:xfrm rot="16200000">
              <a:off x="6456960" y="514728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矩形 176"/>
            <p:cNvSpPr/>
            <p:nvPr/>
          </p:nvSpPr>
          <p:spPr>
            <a:xfrm rot="16200000">
              <a:off x="6456960" y="500832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矩形 177"/>
            <p:cNvSpPr/>
            <p:nvPr/>
          </p:nvSpPr>
          <p:spPr>
            <a:xfrm rot="16200000">
              <a:off x="6456960" y="486936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矩形 178"/>
            <p:cNvSpPr/>
            <p:nvPr/>
          </p:nvSpPr>
          <p:spPr>
            <a:xfrm rot="16200000">
              <a:off x="6456960" y="473040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矩形 179"/>
            <p:cNvSpPr/>
            <p:nvPr/>
          </p:nvSpPr>
          <p:spPr>
            <a:xfrm rot="16200000">
              <a:off x="6635160" y="542520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矩形 181"/>
            <p:cNvSpPr/>
            <p:nvPr/>
          </p:nvSpPr>
          <p:spPr>
            <a:xfrm rot="16200000">
              <a:off x="6635160" y="529272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00" name="直接箭头连接符 186"/>
          <p:cNvCxnSpPr>
            <a:stCxn id="52" idx="1"/>
            <a:endCxn id="54" idx="3"/>
          </p:cNvCxnSpPr>
          <p:nvPr/>
        </p:nvCxnSpPr>
        <p:spPr>
          <a:xfrm flipH="1">
            <a:off x="4165200" y="5790600"/>
            <a:ext cx="1438200" cy="3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01" name="矩形 187"/>
          <p:cNvSpPr/>
          <p:nvPr/>
        </p:nvSpPr>
        <p:spPr>
          <a:xfrm>
            <a:off x="4699080" y="6000840"/>
            <a:ext cx="100080" cy="106200"/>
          </a:xfrm>
          <a:prstGeom prst="rect">
            <a:avLst/>
          </a:prstGeom>
          <a:solidFill>
            <a:srgbClr val="cc0099"/>
          </a:solidFill>
          <a:ln w="324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矩形 188"/>
          <p:cNvSpPr/>
          <p:nvPr/>
        </p:nvSpPr>
        <p:spPr>
          <a:xfrm>
            <a:off x="4548240" y="6000840"/>
            <a:ext cx="101520" cy="106200"/>
          </a:xfrm>
          <a:prstGeom prst="rect">
            <a:avLst/>
          </a:prstGeom>
          <a:solidFill>
            <a:srgbClr val="cc0099"/>
          </a:solidFill>
          <a:ln w="324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矩形 192"/>
          <p:cNvSpPr/>
          <p:nvPr/>
        </p:nvSpPr>
        <p:spPr>
          <a:xfrm>
            <a:off x="4552920" y="5843520"/>
            <a:ext cx="101520" cy="108000"/>
          </a:xfrm>
          <a:prstGeom prst="rect">
            <a:avLst/>
          </a:prstGeom>
          <a:solidFill>
            <a:srgbClr val="9bbb5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矩形 193"/>
          <p:cNvSpPr/>
          <p:nvPr/>
        </p:nvSpPr>
        <p:spPr>
          <a:xfrm>
            <a:off x="4703760" y="5843520"/>
            <a:ext cx="100080" cy="108000"/>
          </a:xfrm>
          <a:prstGeom prst="rect">
            <a:avLst/>
          </a:prstGeom>
          <a:solidFill>
            <a:srgbClr val="9bbb5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矩形 194"/>
          <p:cNvSpPr/>
          <p:nvPr/>
        </p:nvSpPr>
        <p:spPr>
          <a:xfrm>
            <a:off x="4853160" y="5843520"/>
            <a:ext cx="101520" cy="108000"/>
          </a:xfrm>
          <a:prstGeom prst="rect">
            <a:avLst/>
          </a:prstGeom>
          <a:solidFill>
            <a:srgbClr val="9bbb5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矩形 195"/>
          <p:cNvSpPr/>
          <p:nvPr/>
        </p:nvSpPr>
        <p:spPr>
          <a:xfrm>
            <a:off x="5003640" y="5843520"/>
            <a:ext cx="100080" cy="108000"/>
          </a:xfrm>
          <a:prstGeom prst="rect">
            <a:avLst/>
          </a:prstGeom>
          <a:solidFill>
            <a:srgbClr val="9bbb5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矩形 196"/>
          <p:cNvSpPr/>
          <p:nvPr/>
        </p:nvSpPr>
        <p:spPr>
          <a:xfrm>
            <a:off x="5154480" y="5843520"/>
            <a:ext cx="100080" cy="108000"/>
          </a:xfrm>
          <a:prstGeom prst="rect">
            <a:avLst/>
          </a:prstGeom>
          <a:solidFill>
            <a:srgbClr val="9bbb5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矩形 197"/>
          <p:cNvSpPr/>
          <p:nvPr/>
        </p:nvSpPr>
        <p:spPr>
          <a:xfrm>
            <a:off x="4398840" y="6000840"/>
            <a:ext cx="100080" cy="106200"/>
          </a:xfrm>
          <a:prstGeom prst="rect">
            <a:avLst/>
          </a:prstGeom>
          <a:solidFill>
            <a:srgbClr val="9bbb5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矩形 198"/>
          <p:cNvSpPr/>
          <p:nvPr/>
        </p:nvSpPr>
        <p:spPr>
          <a:xfrm>
            <a:off x="4403880" y="5843520"/>
            <a:ext cx="99720" cy="108000"/>
          </a:xfrm>
          <a:prstGeom prst="rect">
            <a:avLst/>
          </a:prstGeom>
          <a:solidFill>
            <a:srgbClr val="ff669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矩形 199"/>
          <p:cNvSpPr/>
          <p:nvPr/>
        </p:nvSpPr>
        <p:spPr>
          <a:xfrm>
            <a:off x="4998960" y="6000840"/>
            <a:ext cx="101520" cy="106200"/>
          </a:xfrm>
          <a:prstGeom prst="rect">
            <a:avLst/>
          </a:prstGeom>
          <a:solidFill>
            <a:srgbClr val="ff0000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矩形 200"/>
          <p:cNvSpPr/>
          <p:nvPr/>
        </p:nvSpPr>
        <p:spPr>
          <a:xfrm>
            <a:off x="4849920" y="6000840"/>
            <a:ext cx="100080" cy="106200"/>
          </a:xfrm>
          <a:prstGeom prst="rect">
            <a:avLst/>
          </a:prstGeom>
          <a:solidFill>
            <a:srgbClr val="ff0000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12" name="组合 90"/>
          <p:cNvGrpSpPr/>
          <p:nvPr/>
        </p:nvGrpSpPr>
        <p:grpSpPr>
          <a:xfrm>
            <a:off x="1171440" y="4767120"/>
            <a:ext cx="106560" cy="717840"/>
            <a:chOff x="1171440" y="4767120"/>
            <a:chExt cx="106560" cy="717840"/>
          </a:xfrm>
        </p:grpSpPr>
        <p:sp>
          <p:nvSpPr>
            <p:cNvPr id="113" name="矩形 214"/>
            <p:cNvSpPr/>
            <p:nvPr/>
          </p:nvSpPr>
          <p:spPr>
            <a:xfrm rot="5400000">
              <a:off x="1174320" y="4887360"/>
              <a:ext cx="100440" cy="10656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矩形 215"/>
            <p:cNvSpPr/>
            <p:nvPr/>
          </p:nvSpPr>
          <p:spPr>
            <a:xfrm rot="5400000">
              <a:off x="1174320" y="5010840"/>
              <a:ext cx="100440" cy="10656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矩形 216"/>
            <p:cNvSpPr/>
            <p:nvPr/>
          </p:nvSpPr>
          <p:spPr>
            <a:xfrm rot="5400000">
              <a:off x="1174320" y="5134320"/>
              <a:ext cx="100440" cy="10656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矩形 217"/>
            <p:cNvSpPr/>
            <p:nvPr/>
          </p:nvSpPr>
          <p:spPr>
            <a:xfrm rot="5400000">
              <a:off x="1174320" y="5257800"/>
              <a:ext cx="100440" cy="10656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矩形 218"/>
            <p:cNvSpPr/>
            <p:nvPr/>
          </p:nvSpPr>
          <p:spPr>
            <a:xfrm rot="5400000">
              <a:off x="1174320" y="5381280"/>
              <a:ext cx="100440" cy="10656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矩形 222"/>
            <p:cNvSpPr/>
            <p:nvPr/>
          </p:nvSpPr>
          <p:spPr>
            <a:xfrm rot="5400000">
              <a:off x="1174320" y="4763880"/>
              <a:ext cx="100440" cy="10656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19" name="直接箭头连接符 224"/>
          <p:cNvCxnSpPr/>
          <p:nvPr/>
        </p:nvCxnSpPr>
        <p:spPr>
          <a:xfrm flipH="1">
            <a:off x="1079280" y="4739760"/>
            <a:ext cx="3600" cy="753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20" name="矩形 246"/>
          <p:cNvSpPr/>
          <p:nvPr/>
        </p:nvSpPr>
        <p:spPr>
          <a:xfrm>
            <a:off x="6935760" y="5886360"/>
            <a:ext cx="101520" cy="108000"/>
          </a:xfrm>
          <a:prstGeom prst="rect">
            <a:avLst/>
          </a:prstGeom>
          <a:solidFill>
            <a:srgbClr val="9bbb5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矩形 247"/>
          <p:cNvSpPr/>
          <p:nvPr/>
        </p:nvSpPr>
        <p:spPr>
          <a:xfrm>
            <a:off x="7122960" y="5886360"/>
            <a:ext cx="100080" cy="108000"/>
          </a:xfrm>
          <a:prstGeom prst="rect">
            <a:avLst/>
          </a:prstGeom>
          <a:solidFill>
            <a:srgbClr val="9bbb5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矩形 249"/>
          <p:cNvSpPr/>
          <p:nvPr/>
        </p:nvSpPr>
        <p:spPr>
          <a:xfrm>
            <a:off x="7308720" y="5886360"/>
            <a:ext cx="101880" cy="108000"/>
          </a:xfrm>
          <a:prstGeom prst="rect">
            <a:avLst/>
          </a:prstGeom>
          <a:solidFill>
            <a:srgbClr val="cc0099"/>
          </a:solidFill>
          <a:ln w="324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矩形 250"/>
          <p:cNvSpPr/>
          <p:nvPr/>
        </p:nvSpPr>
        <p:spPr>
          <a:xfrm>
            <a:off x="7496280" y="5886360"/>
            <a:ext cx="100080" cy="108000"/>
          </a:xfrm>
          <a:prstGeom prst="rect">
            <a:avLst/>
          </a:prstGeom>
          <a:solidFill>
            <a:srgbClr val="cc0099"/>
          </a:solidFill>
          <a:ln w="324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4" name="组合 260"/>
          <p:cNvGrpSpPr/>
          <p:nvPr/>
        </p:nvGrpSpPr>
        <p:grpSpPr>
          <a:xfrm>
            <a:off x="7050240" y="4565520"/>
            <a:ext cx="860400" cy="254160"/>
            <a:chOff x="7050240" y="4565520"/>
            <a:chExt cx="860400" cy="254160"/>
          </a:xfrm>
        </p:grpSpPr>
        <p:sp>
          <p:nvSpPr>
            <p:cNvPr id="125" name="矩形 252"/>
            <p:cNvSpPr/>
            <p:nvPr/>
          </p:nvSpPr>
          <p:spPr>
            <a:xfrm rot="16200000">
              <a:off x="7053480" y="456516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矩形 253"/>
            <p:cNvSpPr/>
            <p:nvPr/>
          </p:nvSpPr>
          <p:spPr>
            <a:xfrm>
              <a:off x="7207560" y="456552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矩形 254"/>
            <p:cNvSpPr/>
            <p:nvPr/>
          </p:nvSpPr>
          <p:spPr>
            <a:xfrm>
              <a:off x="7358040" y="456552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矩形 255"/>
            <p:cNvSpPr/>
            <p:nvPr/>
          </p:nvSpPr>
          <p:spPr>
            <a:xfrm>
              <a:off x="7508880" y="456552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矩形 256"/>
            <p:cNvSpPr/>
            <p:nvPr/>
          </p:nvSpPr>
          <p:spPr>
            <a:xfrm>
              <a:off x="7659720" y="456552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矩形 257"/>
            <p:cNvSpPr/>
            <p:nvPr/>
          </p:nvSpPr>
          <p:spPr>
            <a:xfrm>
              <a:off x="7810200" y="456552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矩形 258"/>
            <p:cNvSpPr/>
            <p:nvPr/>
          </p:nvSpPr>
          <p:spPr>
            <a:xfrm>
              <a:off x="7050240" y="470952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矩形 259"/>
            <p:cNvSpPr/>
            <p:nvPr/>
          </p:nvSpPr>
          <p:spPr>
            <a:xfrm>
              <a:off x="7217640" y="471240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33" name="组合 274"/>
          <p:cNvGrpSpPr/>
          <p:nvPr/>
        </p:nvGrpSpPr>
        <p:grpSpPr>
          <a:xfrm>
            <a:off x="4884840" y="4557600"/>
            <a:ext cx="809640" cy="582840"/>
            <a:chOff x="4884840" y="4557600"/>
            <a:chExt cx="809640" cy="582840"/>
          </a:xfrm>
        </p:grpSpPr>
        <p:sp>
          <p:nvSpPr>
            <p:cNvPr id="134" name="矩形 202"/>
            <p:cNvSpPr/>
            <p:nvPr/>
          </p:nvSpPr>
          <p:spPr>
            <a:xfrm>
              <a:off x="5178240" y="4557600"/>
              <a:ext cx="100440" cy="10728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矩形 203"/>
            <p:cNvSpPr/>
            <p:nvPr/>
          </p:nvSpPr>
          <p:spPr>
            <a:xfrm>
              <a:off x="5316840" y="4557600"/>
              <a:ext cx="100440" cy="10728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矩形 204"/>
            <p:cNvSpPr/>
            <p:nvPr/>
          </p:nvSpPr>
          <p:spPr>
            <a:xfrm>
              <a:off x="5455440" y="4557600"/>
              <a:ext cx="100440" cy="10728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矩形 205"/>
            <p:cNvSpPr/>
            <p:nvPr/>
          </p:nvSpPr>
          <p:spPr>
            <a:xfrm>
              <a:off x="5594040" y="4557600"/>
              <a:ext cx="100440" cy="10728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矩形 206"/>
            <p:cNvSpPr/>
            <p:nvPr/>
          </p:nvSpPr>
          <p:spPr>
            <a:xfrm>
              <a:off x="4893480" y="4721040"/>
              <a:ext cx="100440" cy="10728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矩形 207"/>
            <p:cNvSpPr/>
            <p:nvPr/>
          </p:nvSpPr>
          <p:spPr>
            <a:xfrm>
              <a:off x="5037480" y="4721040"/>
              <a:ext cx="100440" cy="10728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矩形 261"/>
            <p:cNvSpPr/>
            <p:nvPr/>
          </p:nvSpPr>
          <p:spPr>
            <a:xfrm>
              <a:off x="5322240" y="4712760"/>
              <a:ext cx="100440" cy="10728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矩形 262"/>
            <p:cNvSpPr/>
            <p:nvPr/>
          </p:nvSpPr>
          <p:spPr>
            <a:xfrm>
              <a:off x="5178240" y="4712760"/>
              <a:ext cx="100440" cy="10728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矩形 263"/>
            <p:cNvSpPr/>
            <p:nvPr/>
          </p:nvSpPr>
          <p:spPr>
            <a:xfrm>
              <a:off x="5466240" y="4712760"/>
              <a:ext cx="100440" cy="10728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矩形 264"/>
            <p:cNvSpPr/>
            <p:nvPr/>
          </p:nvSpPr>
          <p:spPr>
            <a:xfrm>
              <a:off x="5037480" y="4559760"/>
              <a:ext cx="100440" cy="10728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矩形 265"/>
            <p:cNvSpPr/>
            <p:nvPr/>
          </p:nvSpPr>
          <p:spPr>
            <a:xfrm>
              <a:off x="4893480" y="4559760"/>
              <a:ext cx="100440" cy="10728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矩形 266"/>
            <p:cNvSpPr/>
            <p:nvPr/>
          </p:nvSpPr>
          <p:spPr>
            <a:xfrm>
              <a:off x="5594040" y="470880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矩形 267"/>
            <p:cNvSpPr/>
            <p:nvPr/>
          </p:nvSpPr>
          <p:spPr>
            <a:xfrm>
              <a:off x="4893480" y="487116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矩形 268"/>
            <p:cNvSpPr/>
            <p:nvPr/>
          </p:nvSpPr>
          <p:spPr>
            <a:xfrm>
              <a:off x="5037480" y="487116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矩形 269"/>
            <p:cNvSpPr/>
            <p:nvPr/>
          </p:nvSpPr>
          <p:spPr>
            <a:xfrm>
              <a:off x="5151600" y="487188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矩形 270"/>
            <p:cNvSpPr/>
            <p:nvPr/>
          </p:nvSpPr>
          <p:spPr>
            <a:xfrm>
              <a:off x="5295600" y="487188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矩形 271"/>
            <p:cNvSpPr/>
            <p:nvPr/>
          </p:nvSpPr>
          <p:spPr>
            <a:xfrm>
              <a:off x="5439600" y="487188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矩形 272"/>
            <p:cNvSpPr/>
            <p:nvPr/>
          </p:nvSpPr>
          <p:spPr>
            <a:xfrm>
              <a:off x="5583600" y="487188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矩形 273"/>
            <p:cNvSpPr/>
            <p:nvPr/>
          </p:nvSpPr>
          <p:spPr>
            <a:xfrm>
              <a:off x="4884840" y="503316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53" name="直接连接符 283"/>
          <p:cNvSpPr/>
          <p:nvPr/>
        </p:nvSpPr>
        <p:spPr>
          <a:xfrm flipH="1">
            <a:off x="4114440" y="3762360"/>
            <a:ext cx="555480" cy="6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54" name="直接箭头连接符 285"/>
          <p:cNvCxnSpPr>
            <a:stCxn id="55" idx="2"/>
          </p:cNvCxnSpPr>
          <p:nvPr/>
        </p:nvCxnSpPr>
        <p:spPr>
          <a:xfrm>
            <a:off x="3825000" y="4655160"/>
            <a:ext cx="360" cy="924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55" name="直接箭头连接符 293"/>
          <p:cNvCxnSpPr>
            <a:stCxn id="64" idx="2"/>
          </p:cNvCxnSpPr>
          <p:nvPr/>
        </p:nvCxnSpPr>
        <p:spPr>
          <a:xfrm>
            <a:off x="1079280" y="5828400"/>
            <a:ext cx="291240" cy="302760"/>
          </a:xfrm>
          <a:prstGeom prst="straightConnector1">
            <a:avLst/>
          </a:prstGeom>
          <a:ln w="9360">
            <a:solidFill>
              <a:srgbClr val="000000"/>
            </a:solidFill>
            <a:prstDash val="dashDot"/>
            <a:miter/>
            <a:tailEnd len="med" type="arrow" w="med"/>
          </a:ln>
        </p:spPr>
      </p:cxnSp>
      <p:cxnSp>
        <p:nvCxnSpPr>
          <p:cNvPr id="156" name="直接箭头连接符 298"/>
          <p:cNvCxnSpPr/>
          <p:nvPr/>
        </p:nvCxnSpPr>
        <p:spPr>
          <a:xfrm flipH="1">
            <a:off x="6162120" y="3549240"/>
            <a:ext cx="1080" cy="764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157" name="组合 320"/>
          <p:cNvGrpSpPr/>
          <p:nvPr/>
        </p:nvGrpSpPr>
        <p:grpSpPr>
          <a:xfrm>
            <a:off x="6210360" y="3614400"/>
            <a:ext cx="839880" cy="582840"/>
            <a:chOff x="6210360" y="3614400"/>
            <a:chExt cx="839880" cy="582840"/>
          </a:xfrm>
        </p:grpSpPr>
        <p:sp>
          <p:nvSpPr>
            <p:cNvPr id="158" name="矩形 299"/>
            <p:cNvSpPr/>
            <p:nvPr/>
          </p:nvSpPr>
          <p:spPr>
            <a:xfrm rot="16200000">
              <a:off x="6213600" y="362052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矩形 300"/>
            <p:cNvSpPr/>
            <p:nvPr/>
          </p:nvSpPr>
          <p:spPr>
            <a:xfrm rot="16200000">
              <a:off x="6366240" y="362052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矩形 301"/>
            <p:cNvSpPr/>
            <p:nvPr/>
          </p:nvSpPr>
          <p:spPr>
            <a:xfrm rot="16200000">
              <a:off x="6518880" y="362052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矩形 302"/>
            <p:cNvSpPr/>
            <p:nvPr/>
          </p:nvSpPr>
          <p:spPr>
            <a:xfrm>
              <a:off x="6803640" y="3622680"/>
              <a:ext cx="100440" cy="10728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矩形 303"/>
            <p:cNvSpPr/>
            <p:nvPr/>
          </p:nvSpPr>
          <p:spPr>
            <a:xfrm>
              <a:off x="6659280" y="3622680"/>
              <a:ext cx="100440" cy="10728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矩形 304"/>
            <p:cNvSpPr/>
            <p:nvPr/>
          </p:nvSpPr>
          <p:spPr>
            <a:xfrm rot="16200000">
              <a:off x="6946560" y="361116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矩形 305"/>
            <p:cNvSpPr/>
            <p:nvPr/>
          </p:nvSpPr>
          <p:spPr>
            <a:xfrm rot="16200000">
              <a:off x="6218280" y="37796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矩形 306"/>
            <p:cNvSpPr/>
            <p:nvPr/>
          </p:nvSpPr>
          <p:spPr>
            <a:xfrm rot="16200000">
              <a:off x="6357600" y="377640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矩形 307"/>
            <p:cNvSpPr/>
            <p:nvPr/>
          </p:nvSpPr>
          <p:spPr>
            <a:xfrm rot="16200000">
              <a:off x="6504840" y="37778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矩形 308"/>
            <p:cNvSpPr/>
            <p:nvPr/>
          </p:nvSpPr>
          <p:spPr>
            <a:xfrm>
              <a:off x="6649200" y="3776400"/>
              <a:ext cx="100440" cy="10728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矩形 309"/>
            <p:cNvSpPr/>
            <p:nvPr/>
          </p:nvSpPr>
          <p:spPr>
            <a:xfrm>
              <a:off x="6805800" y="3776400"/>
              <a:ext cx="100440" cy="10728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矩形 310"/>
            <p:cNvSpPr/>
            <p:nvPr/>
          </p:nvSpPr>
          <p:spPr>
            <a:xfrm>
              <a:off x="6946560" y="377208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矩形 311"/>
            <p:cNvSpPr/>
            <p:nvPr/>
          </p:nvSpPr>
          <p:spPr>
            <a:xfrm>
              <a:off x="6216480" y="393588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矩形 312"/>
            <p:cNvSpPr/>
            <p:nvPr/>
          </p:nvSpPr>
          <p:spPr>
            <a:xfrm>
              <a:off x="6359400" y="393588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矩形 313"/>
            <p:cNvSpPr/>
            <p:nvPr/>
          </p:nvSpPr>
          <p:spPr>
            <a:xfrm>
              <a:off x="6510600" y="3935880"/>
              <a:ext cx="100440" cy="10728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矩形 316"/>
            <p:cNvSpPr/>
            <p:nvPr/>
          </p:nvSpPr>
          <p:spPr>
            <a:xfrm>
              <a:off x="6653880" y="393588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矩形 317"/>
            <p:cNvSpPr/>
            <p:nvPr/>
          </p:nvSpPr>
          <p:spPr>
            <a:xfrm>
              <a:off x="6796800" y="393588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矩形 318"/>
            <p:cNvSpPr/>
            <p:nvPr/>
          </p:nvSpPr>
          <p:spPr>
            <a:xfrm>
              <a:off x="6940080" y="393588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矩形 319"/>
            <p:cNvSpPr/>
            <p:nvPr/>
          </p:nvSpPr>
          <p:spPr>
            <a:xfrm>
              <a:off x="6210360" y="4089960"/>
              <a:ext cx="100440" cy="10728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177" name="直接箭头连接符 163"/>
          <p:cNvCxnSpPr/>
          <p:nvPr/>
        </p:nvCxnSpPr>
        <p:spPr>
          <a:xfrm>
            <a:off x="6162480" y="977760"/>
            <a:ext cx="1080" cy="3229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78" name="TextBox 180"/>
          <p:cNvSpPr/>
          <p:nvPr/>
        </p:nvSpPr>
        <p:spPr>
          <a:xfrm>
            <a:off x="5274360" y="2575080"/>
            <a:ext cx="16225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yceraldehyde-3-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TextBox 190"/>
          <p:cNvSpPr/>
          <p:nvPr/>
        </p:nvSpPr>
        <p:spPr>
          <a:xfrm>
            <a:off x="1474200" y="404640"/>
            <a:ext cx="118188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UDP-Gluco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80" name="直接箭头连接符 4"/>
          <p:cNvCxnSpPr>
            <a:endCxn id="48" idx="0"/>
          </p:cNvCxnSpPr>
          <p:nvPr/>
        </p:nvCxnSpPr>
        <p:spPr>
          <a:xfrm>
            <a:off x="2062080" y="712800"/>
            <a:ext cx="1080" cy="5878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181" name="组合 5"/>
          <p:cNvGrpSpPr/>
          <p:nvPr/>
        </p:nvGrpSpPr>
        <p:grpSpPr>
          <a:xfrm>
            <a:off x="2334960" y="767880"/>
            <a:ext cx="849240" cy="425880"/>
            <a:chOff x="2334960" y="767880"/>
            <a:chExt cx="849240" cy="425880"/>
          </a:xfrm>
        </p:grpSpPr>
        <p:sp>
          <p:nvSpPr>
            <p:cNvPr id="182" name="矩形 191"/>
            <p:cNvSpPr/>
            <p:nvPr/>
          </p:nvSpPr>
          <p:spPr>
            <a:xfrm rot="16200000">
              <a:off x="2344320" y="76464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矩形 201"/>
            <p:cNvSpPr/>
            <p:nvPr/>
          </p:nvSpPr>
          <p:spPr>
            <a:xfrm rot="16200000">
              <a:off x="2491920" y="76464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矩形 208"/>
            <p:cNvSpPr/>
            <p:nvPr/>
          </p:nvSpPr>
          <p:spPr>
            <a:xfrm rot="16200000">
              <a:off x="2639160" y="764640"/>
              <a:ext cx="10044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矩形 209"/>
            <p:cNvSpPr/>
            <p:nvPr/>
          </p:nvSpPr>
          <p:spPr>
            <a:xfrm rot="5400000">
              <a:off x="2637360" y="9374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矩形 210"/>
            <p:cNvSpPr/>
            <p:nvPr/>
          </p:nvSpPr>
          <p:spPr>
            <a:xfrm rot="5400000">
              <a:off x="2489400" y="9374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矩形 211"/>
            <p:cNvSpPr/>
            <p:nvPr/>
          </p:nvSpPr>
          <p:spPr>
            <a:xfrm rot="5400000">
              <a:off x="2341800" y="9374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矩形 212"/>
            <p:cNvSpPr/>
            <p:nvPr/>
          </p:nvSpPr>
          <p:spPr>
            <a:xfrm rot="5400000">
              <a:off x="2786040" y="76500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矩形 213"/>
            <p:cNvSpPr/>
            <p:nvPr/>
          </p:nvSpPr>
          <p:spPr>
            <a:xfrm rot="5400000">
              <a:off x="2933280" y="76500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矩形 219"/>
            <p:cNvSpPr/>
            <p:nvPr/>
          </p:nvSpPr>
          <p:spPr>
            <a:xfrm rot="5400000">
              <a:off x="3080520" y="76500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矩形 220"/>
            <p:cNvSpPr/>
            <p:nvPr/>
          </p:nvSpPr>
          <p:spPr>
            <a:xfrm rot="5400000">
              <a:off x="2784960" y="9374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矩形 221"/>
            <p:cNvSpPr/>
            <p:nvPr/>
          </p:nvSpPr>
          <p:spPr>
            <a:xfrm rot="5400000">
              <a:off x="2932920" y="9374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矩形 223"/>
            <p:cNvSpPr/>
            <p:nvPr/>
          </p:nvSpPr>
          <p:spPr>
            <a:xfrm rot="5400000">
              <a:off x="3080520" y="93744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矩形 226"/>
            <p:cNvSpPr/>
            <p:nvPr/>
          </p:nvSpPr>
          <p:spPr>
            <a:xfrm rot="5400000">
              <a:off x="2338200" y="109008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矩形 227"/>
            <p:cNvSpPr/>
            <p:nvPr/>
          </p:nvSpPr>
          <p:spPr>
            <a:xfrm rot="5400000">
              <a:off x="2495160" y="1090080"/>
              <a:ext cx="10044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矩形 228"/>
            <p:cNvSpPr/>
            <p:nvPr/>
          </p:nvSpPr>
          <p:spPr>
            <a:xfrm>
              <a:off x="2636280" y="1085040"/>
              <a:ext cx="100440" cy="10692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矩形 229"/>
            <p:cNvSpPr/>
            <p:nvPr/>
          </p:nvSpPr>
          <p:spPr>
            <a:xfrm>
              <a:off x="2786760" y="1085040"/>
              <a:ext cx="100440" cy="10692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98" name="TextBox 230"/>
          <p:cNvSpPr/>
          <p:nvPr/>
        </p:nvSpPr>
        <p:spPr>
          <a:xfrm>
            <a:off x="38160" y="1292400"/>
            <a:ext cx="10555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crose-6-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99" name="直接箭头连接符 10"/>
          <p:cNvCxnSpPr>
            <a:stCxn id="198" idx="3"/>
            <a:endCxn id="48" idx="1"/>
          </p:cNvCxnSpPr>
          <p:nvPr/>
        </p:nvCxnSpPr>
        <p:spPr>
          <a:xfrm>
            <a:off x="1093680" y="1445760"/>
            <a:ext cx="595800" cy="8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0" name="直接箭头连接符 12"/>
          <p:cNvCxnSpPr>
            <a:stCxn id="179" idx="1"/>
            <a:endCxn id="198" idx="0"/>
          </p:cNvCxnSpPr>
          <p:nvPr/>
        </p:nvCxnSpPr>
        <p:spPr>
          <a:xfrm flipH="1">
            <a:off x="565920" y="558000"/>
            <a:ext cx="908640" cy="7347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1" name="直接箭头连接符 231"/>
          <p:cNvCxnSpPr/>
          <p:nvPr/>
        </p:nvCxnSpPr>
        <p:spPr>
          <a:xfrm flipH="1">
            <a:off x="2080440" y="1617840"/>
            <a:ext cx="1080" cy="443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02" name="TextBox 232"/>
          <p:cNvSpPr/>
          <p:nvPr/>
        </p:nvSpPr>
        <p:spPr>
          <a:xfrm>
            <a:off x="1545480" y="2112840"/>
            <a:ext cx="10555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crose-6-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03" name="直接箭头连接符 30"/>
          <p:cNvCxnSpPr>
            <a:stCxn id="202" idx="3"/>
          </p:cNvCxnSpPr>
          <p:nvPr/>
        </p:nvCxnSpPr>
        <p:spPr>
          <a:xfrm>
            <a:off x="2601000" y="2266200"/>
            <a:ext cx="1050840" cy="1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04" name="直接连接符 32"/>
          <p:cNvSpPr/>
          <p:nvPr/>
        </p:nvSpPr>
        <p:spPr>
          <a:xfrm>
            <a:off x="2790720" y="1839960"/>
            <a:ext cx="0" cy="895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05" name="直接箭头连接符 34"/>
          <p:cNvCxnSpPr>
            <a:endCxn id="206" idx="1"/>
          </p:cNvCxnSpPr>
          <p:nvPr/>
        </p:nvCxnSpPr>
        <p:spPr>
          <a:xfrm flipV="1">
            <a:off x="2782800" y="1834560"/>
            <a:ext cx="873720" cy="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7" name="直接箭头连接符 236"/>
          <p:cNvCxnSpPr/>
          <p:nvPr/>
        </p:nvCxnSpPr>
        <p:spPr>
          <a:xfrm>
            <a:off x="2790720" y="2736360"/>
            <a:ext cx="8611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06" name="TextBox 237"/>
          <p:cNvSpPr/>
          <p:nvPr/>
        </p:nvSpPr>
        <p:spPr>
          <a:xfrm>
            <a:off x="3656160" y="1681200"/>
            <a:ext cx="110736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α-D-Gluco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TextBox 238"/>
          <p:cNvSpPr/>
          <p:nvPr/>
        </p:nvSpPr>
        <p:spPr>
          <a:xfrm>
            <a:off x="3677760" y="2112840"/>
            <a:ext cx="110592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-D-Gluco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TextBox 239"/>
          <p:cNvSpPr/>
          <p:nvPr/>
        </p:nvSpPr>
        <p:spPr>
          <a:xfrm>
            <a:off x="3679200" y="2581200"/>
            <a:ext cx="117756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-ketosucros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10" name="直接箭头连接符 38"/>
          <p:cNvCxnSpPr/>
          <p:nvPr/>
        </p:nvCxnSpPr>
        <p:spPr>
          <a:xfrm flipH="1">
            <a:off x="1382400" y="1839600"/>
            <a:ext cx="699120" cy="1080"/>
          </a:xfrm>
          <a:prstGeom prst="straightConnector1">
            <a:avLst/>
          </a:prstGeom>
          <a:ln w="9360">
            <a:solidFill>
              <a:srgbClr val="000000"/>
            </a:solidFill>
            <a:prstDash val="dashDot"/>
            <a:miter/>
            <a:tailEnd len="med" type="arrow" w="med"/>
          </a:ln>
        </p:spPr>
      </p:cxnSp>
      <p:sp>
        <p:nvSpPr>
          <p:cNvPr id="211" name="TextBox 39"/>
          <p:cNvSpPr/>
          <p:nvPr/>
        </p:nvSpPr>
        <p:spPr>
          <a:xfrm>
            <a:off x="570960" y="1647720"/>
            <a:ext cx="803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or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2" name="组合 51"/>
          <p:cNvGrpSpPr/>
          <p:nvPr/>
        </p:nvGrpSpPr>
        <p:grpSpPr>
          <a:xfrm>
            <a:off x="2843280" y="1898640"/>
            <a:ext cx="677880" cy="108000"/>
            <a:chOff x="2843280" y="1898640"/>
            <a:chExt cx="677880" cy="108000"/>
          </a:xfrm>
        </p:grpSpPr>
        <p:sp>
          <p:nvSpPr>
            <p:cNvPr id="213" name="矩形 240"/>
            <p:cNvSpPr/>
            <p:nvPr/>
          </p:nvSpPr>
          <p:spPr>
            <a:xfrm>
              <a:off x="2843280" y="1898640"/>
              <a:ext cx="100440" cy="10800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矩形 241"/>
            <p:cNvSpPr/>
            <p:nvPr/>
          </p:nvSpPr>
          <p:spPr>
            <a:xfrm rot="16200000">
              <a:off x="2990520" y="1899000"/>
              <a:ext cx="101520" cy="10728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矩形 242"/>
            <p:cNvSpPr/>
            <p:nvPr/>
          </p:nvSpPr>
          <p:spPr>
            <a:xfrm>
              <a:off x="3132000" y="1898640"/>
              <a:ext cx="100440" cy="10800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矩形 243"/>
            <p:cNvSpPr/>
            <p:nvPr/>
          </p:nvSpPr>
          <p:spPr>
            <a:xfrm>
              <a:off x="3276360" y="1898640"/>
              <a:ext cx="100440" cy="10800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矩形 244"/>
            <p:cNvSpPr/>
            <p:nvPr/>
          </p:nvSpPr>
          <p:spPr>
            <a:xfrm>
              <a:off x="3420720" y="1898640"/>
              <a:ext cx="100440" cy="10800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18" name="TextBox 245"/>
          <p:cNvSpPr/>
          <p:nvPr/>
        </p:nvSpPr>
        <p:spPr>
          <a:xfrm>
            <a:off x="5394600" y="1341360"/>
            <a:ext cx="144396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-D-Fructose-6-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19" name="组合 248"/>
          <p:cNvGrpSpPr/>
          <p:nvPr/>
        </p:nvGrpSpPr>
        <p:grpSpPr>
          <a:xfrm>
            <a:off x="2843280" y="2386080"/>
            <a:ext cx="677880" cy="106200"/>
            <a:chOff x="2843280" y="2386080"/>
            <a:chExt cx="677880" cy="106200"/>
          </a:xfrm>
        </p:grpSpPr>
        <p:sp>
          <p:nvSpPr>
            <p:cNvPr id="220" name="矩形 251"/>
            <p:cNvSpPr/>
            <p:nvPr/>
          </p:nvSpPr>
          <p:spPr>
            <a:xfrm>
              <a:off x="2843280" y="2386080"/>
              <a:ext cx="100440" cy="10620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矩形 275"/>
            <p:cNvSpPr/>
            <p:nvPr/>
          </p:nvSpPr>
          <p:spPr>
            <a:xfrm rot="16200000">
              <a:off x="2991240" y="2385000"/>
              <a:ext cx="99720" cy="10728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矩形 276"/>
            <p:cNvSpPr/>
            <p:nvPr/>
          </p:nvSpPr>
          <p:spPr>
            <a:xfrm>
              <a:off x="3132000" y="2386080"/>
              <a:ext cx="100440" cy="10620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矩形 277"/>
            <p:cNvSpPr/>
            <p:nvPr/>
          </p:nvSpPr>
          <p:spPr>
            <a:xfrm>
              <a:off x="3276360" y="2386080"/>
              <a:ext cx="100440" cy="10620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矩形 278"/>
            <p:cNvSpPr/>
            <p:nvPr/>
          </p:nvSpPr>
          <p:spPr>
            <a:xfrm>
              <a:off x="3420720" y="2386080"/>
              <a:ext cx="100440" cy="10620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225" name="直接箭头连接符 53"/>
          <p:cNvCxnSpPr>
            <a:stCxn id="206" idx="0"/>
            <a:endCxn id="67" idx="1"/>
          </p:cNvCxnSpPr>
          <p:nvPr/>
        </p:nvCxnSpPr>
        <p:spPr>
          <a:xfrm flipV="1">
            <a:off x="4209840" y="826560"/>
            <a:ext cx="1183680" cy="855000"/>
          </a:xfrm>
          <a:prstGeom prst="straightConnector1">
            <a:avLst/>
          </a:prstGeom>
          <a:ln w="9360">
            <a:solidFill>
              <a:srgbClr val="000000"/>
            </a:solidFill>
            <a:prstDash val="dashDot"/>
            <a:miter/>
            <a:tailEnd len="med" type="arrow" w="med"/>
          </a:ln>
        </p:spPr>
      </p:cxnSp>
      <p:grpSp>
        <p:nvGrpSpPr>
          <p:cNvPr id="226" name="组合 85"/>
          <p:cNvGrpSpPr/>
          <p:nvPr/>
        </p:nvGrpSpPr>
        <p:grpSpPr>
          <a:xfrm>
            <a:off x="6292800" y="1052640"/>
            <a:ext cx="839880" cy="250560"/>
            <a:chOff x="6292800" y="1052640"/>
            <a:chExt cx="839880" cy="250560"/>
          </a:xfrm>
        </p:grpSpPr>
        <p:sp>
          <p:nvSpPr>
            <p:cNvPr id="227" name="矩形 279"/>
            <p:cNvSpPr/>
            <p:nvPr/>
          </p:nvSpPr>
          <p:spPr>
            <a:xfrm>
              <a:off x="6436800" y="1052640"/>
              <a:ext cx="100440" cy="10692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矩形 280"/>
            <p:cNvSpPr/>
            <p:nvPr/>
          </p:nvSpPr>
          <p:spPr>
            <a:xfrm>
              <a:off x="6292800" y="1052640"/>
              <a:ext cx="100440" cy="106920"/>
            </a:xfrm>
            <a:prstGeom prst="rect">
              <a:avLst/>
            </a:prstGeom>
            <a:solidFill>
              <a:srgbClr val="9bbb5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矩形 281"/>
            <p:cNvSpPr/>
            <p:nvPr/>
          </p:nvSpPr>
          <p:spPr>
            <a:xfrm rot="16200000">
              <a:off x="6584040" y="1052280"/>
              <a:ext cx="10008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矩形 282"/>
            <p:cNvSpPr/>
            <p:nvPr/>
          </p:nvSpPr>
          <p:spPr>
            <a:xfrm rot="16200000">
              <a:off x="6731280" y="1053720"/>
              <a:ext cx="10008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矩形 284"/>
            <p:cNvSpPr/>
            <p:nvPr/>
          </p:nvSpPr>
          <p:spPr>
            <a:xfrm>
              <a:off x="6875640" y="1052640"/>
              <a:ext cx="100440" cy="10692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矩形 286"/>
            <p:cNvSpPr/>
            <p:nvPr/>
          </p:nvSpPr>
          <p:spPr>
            <a:xfrm>
              <a:off x="7032240" y="1052640"/>
              <a:ext cx="100440" cy="106920"/>
            </a:xfrm>
            <a:prstGeom prst="rect">
              <a:avLst/>
            </a:prstGeom>
            <a:solidFill>
              <a:srgbClr val="00ff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矩形 287"/>
            <p:cNvSpPr/>
            <p:nvPr/>
          </p:nvSpPr>
          <p:spPr>
            <a:xfrm>
              <a:off x="6302520" y="1196280"/>
              <a:ext cx="100440" cy="10692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矩形 288"/>
            <p:cNvSpPr/>
            <p:nvPr/>
          </p:nvSpPr>
          <p:spPr>
            <a:xfrm>
              <a:off x="6453720" y="1196280"/>
              <a:ext cx="100440" cy="10692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矩形 289"/>
            <p:cNvSpPr/>
            <p:nvPr/>
          </p:nvSpPr>
          <p:spPr>
            <a:xfrm>
              <a:off x="6596640" y="1196280"/>
              <a:ext cx="100440" cy="10692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矩形 290"/>
            <p:cNvSpPr/>
            <p:nvPr/>
          </p:nvSpPr>
          <p:spPr>
            <a:xfrm>
              <a:off x="6739920" y="1196280"/>
              <a:ext cx="100440" cy="106920"/>
            </a:xfrm>
            <a:prstGeom prst="rect">
              <a:avLst/>
            </a:prstGeom>
            <a:solidFill>
              <a:srgbClr val="0099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237" name="直接箭头连接符 56"/>
          <p:cNvCxnSpPr>
            <a:stCxn id="67" idx="3"/>
          </p:cNvCxnSpPr>
          <p:nvPr/>
        </p:nvCxnSpPr>
        <p:spPr>
          <a:xfrm flipV="1">
            <a:off x="6808320" y="818640"/>
            <a:ext cx="721800" cy="8280"/>
          </a:xfrm>
          <a:prstGeom prst="straightConnector1">
            <a:avLst/>
          </a:prstGeom>
          <a:ln w="9360">
            <a:solidFill>
              <a:srgbClr val="000000"/>
            </a:solidFill>
            <a:prstDash val="dashDot"/>
            <a:miter/>
            <a:tailEnd len="med" type="arrow" w="med"/>
          </a:ln>
        </p:spPr>
      </p:cxnSp>
      <p:sp>
        <p:nvSpPr>
          <p:cNvPr id="238" name="圆角矩形 57"/>
          <p:cNvSpPr/>
          <p:nvPr/>
        </p:nvSpPr>
        <p:spPr>
          <a:xfrm>
            <a:off x="7545240" y="703440"/>
            <a:ext cx="1203480" cy="2077920"/>
          </a:xfrm>
          <a:custGeom>
            <a:avLst/>
            <a:gdLst>
              <a:gd name="textAreaLeft" fmla="*/ 58680 w 1203480"/>
              <a:gd name="textAreaRight" fmla="*/ 1144800 w 1203480"/>
              <a:gd name="textAreaTop" fmla="*/ 58680 h 2077920"/>
              <a:gd name="textAreaBottom" fmla="*/ 2019240 h 2077920"/>
            </a:gdLst>
            <a:ahLst/>
            <a:rect l="textAreaLeft" t="textAreaTop" r="textAreaRight" b="textAreaBottom"/>
            <a:pathLst>
              <a:path w="21600" h="37290">
                <a:moveTo>
                  <a:pt x="3600" y="0"/>
                </a:moveTo>
                <a:arcTo wR="3600" hR="3600" stAng="16200000" swAng="-5400000"/>
                <a:lnTo>
                  <a:pt x="0" y="33690"/>
                </a:lnTo>
                <a:arcTo wR="3600" hR="3600" stAng="10800000" swAng="-5400000"/>
                <a:lnTo>
                  <a:pt x="18000" y="37290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Box 58"/>
          <p:cNvSpPr/>
          <p:nvPr/>
        </p:nvSpPr>
        <p:spPr>
          <a:xfrm>
            <a:off x="7596360" y="922320"/>
            <a:ext cx="1152360" cy="132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nto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hosphat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hway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40" name="直接箭头连接符 291"/>
          <p:cNvCxnSpPr/>
          <p:nvPr/>
        </p:nvCxnSpPr>
        <p:spPr>
          <a:xfrm>
            <a:off x="6162480" y="2293560"/>
            <a:ext cx="1080" cy="291240"/>
          </a:xfrm>
          <a:prstGeom prst="straightConnector1">
            <a:avLst/>
          </a:prstGeom>
          <a:ln w="9360">
            <a:solidFill>
              <a:srgbClr val="000000"/>
            </a:solidFill>
            <a:prstDash val="dashDot"/>
            <a:miter/>
            <a:tailEnd len="med" type="arrow" w="med"/>
          </a:ln>
        </p:spPr>
      </p:cxnSp>
      <p:cxnSp>
        <p:nvCxnSpPr>
          <p:cNvPr id="241" name="直接箭头连接符 69"/>
          <p:cNvCxnSpPr/>
          <p:nvPr/>
        </p:nvCxnSpPr>
        <p:spPr>
          <a:xfrm flipH="1">
            <a:off x="6875280" y="2717280"/>
            <a:ext cx="583200" cy="10440"/>
          </a:xfrm>
          <a:prstGeom prst="straightConnector1">
            <a:avLst/>
          </a:prstGeom>
          <a:ln w="9360">
            <a:solidFill>
              <a:srgbClr val="000000"/>
            </a:solidFill>
            <a:prstDash val="dashDot"/>
            <a:miter/>
            <a:tailEnd len="med" type="arrow" w="med"/>
          </a:ln>
        </p:spPr>
      </p:cxnSp>
      <p:sp>
        <p:nvSpPr>
          <p:cNvPr id="242" name="任意多边形 74"/>
          <p:cNvSpPr/>
          <p:nvPr/>
        </p:nvSpPr>
        <p:spPr>
          <a:xfrm>
            <a:off x="1547640" y="5843520"/>
            <a:ext cx="1905120" cy="900360"/>
          </a:xfrm>
          <a:custGeom>
            <a:avLst/>
            <a:gdLst/>
            <a:ahLst/>
            <a:rect l="l" t="t" r="r" b="b"/>
            <a:pathLst>
              <a:path w="1905115" h="809625">
                <a:moveTo>
                  <a:pt x="276225" y="85725"/>
                </a:moveTo>
                <a:cubicBezTo>
                  <a:pt x="257175" y="87312"/>
                  <a:pt x="192167" y="100489"/>
                  <a:pt x="171450" y="114300"/>
                </a:cubicBezTo>
                <a:cubicBezTo>
                  <a:pt x="134521" y="138919"/>
                  <a:pt x="153735" y="129730"/>
                  <a:pt x="114300" y="142875"/>
                </a:cubicBezTo>
                <a:cubicBezTo>
                  <a:pt x="59705" y="224767"/>
                  <a:pt x="132400" y="128395"/>
                  <a:pt x="66675" y="180975"/>
                </a:cubicBezTo>
                <a:cubicBezTo>
                  <a:pt x="57736" y="188126"/>
                  <a:pt x="55720" y="201455"/>
                  <a:pt x="47625" y="209550"/>
                </a:cubicBezTo>
                <a:cubicBezTo>
                  <a:pt x="39530" y="217645"/>
                  <a:pt x="28575" y="222250"/>
                  <a:pt x="19050" y="228600"/>
                </a:cubicBezTo>
                <a:cubicBezTo>
                  <a:pt x="14558" y="242075"/>
                  <a:pt x="0" y="283315"/>
                  <a:pt x="0" y="295275"/>
                </a:cubicBezTo>
                <a:cubicBezTo>
                  <a:pt x="0" y="336672"/>
                  <a:pt x="1896" y="378412"/>
                  <a:pt x="9525" y="419100"/>
                </a:cubicBezTo>
                <a:cubicBezTo>
                  <a:pt x="11635" y="430352"/>
                  <a:pt x="21246" y="438881"/>
                  <a:pt x="28575" y="447675"/>
                </a:cubicBezTo>
                <a:cubicBezTo>
                  <a:pt x="51494" y="475177"/>
                  <a:pt x="57628" y="476569"/>
                  <a:pt x="85725" y="495300"/>
                </a:cubicBezTo>
                <a:cubicBezTo>
                  <a:pt x="104268" y="550930"/>
                  <a:pt x="80741" y="499841"/>
                  <a:pt x="123825" y="542925"/>
                </a:cubicBezTo>
                <a:cubicBezTo>
                  <a:pt x="131920" y="551020"/>
                  <a:pt x="133936" y="564349"/>
                  <a:pt x="142875" y="571500"/>
                </a:cubicBezTo>
                <a:cubicBezTo>
                  <a:pt x="150715" y="577772"/>
                  <a:pt x="162673" y="576149"/>
                  <a:pt x="171450" y="581025"/>
                </a:cubicBezTo>
                <a:cubicBezTo>
                  <a:pt x="191464" y="592144"/>
                  <a:pt x="228600" y="619125"/>
                  <a:pt x="228600" y="619125"/>
                </a:cubicBezTo>
                <a:cubicBezTo>
                  <a:pt x="231775" y="609600"/>
                  <a:pt x="233635" y="599530"/>
                  <a:pt x="238125" y="590550"/>
                </a:cubicBezTo>
                <a:cubicBezTo>
                  <a:pt x="243245" y="580311"/>
                  <a:pt x="252666" y="572497"/>
                  <a:pt x="257175" y="561975"/>
                </a:cubicBezTo>
                <a:cubicBezTo>
                  <a:pt x="273008" y="525032"/>
                  <a:pt x="257739" y="519388"/>
                  <a:pt x="285750" y="485775"/>
                </a:cubicBezTo>
                <a:cubicBezTo>
                  <a:pt x="293079" y="476981"/>
                  <a:pt x="304800" y="473075"/>
                  <a:pt x="314325" y="466725"/>
                </a:cubicBezTo>
                <a:cubicBezTo>
                  <a:pt x="333375" y="473075"/>
                  <a:pt x="365125" y="466725"/>
                  <a:pt x="371475" y="485775"/>
                </a:cubicBezTo>
                <a:lnTo>
                  <a:pt x="390525" y="542925"/>
                </a:lnTo>
                <a:lnTo>
                  <a:pt x="400050" y="571500"/>
                </a:lnTo>
                <a:cubicBezTo>
                  <a:pt x="403225" y="609600"/>
                  <a:pt x="404522" y="647903"/>
                  <a:pt x="409575" y="685800"/>
                </a:cubicBezTo>
                <a:cubicBezTo>
                  <a:pt x="410902" y="695752"/>
                  <a:pt x="416342" y="704721"/>
                  <a:pt x="419100" y="714375"/>
                </a:cubicBezTo>
                <a:cubicBezTo>
                  <a:pt x="422696" y="726962"/>
                  <a:pt x="425450" y="739775"/>
                  <a:pt x="428625" y="752475"/>
                </a:cubicBezTo>
                <a:cubicBezTo>
                  <a:pt x="438150" y="749300"/>
                  <a:pt x="450100" y="750050"/>
                  <a:pt x="457200" y="742950"/>
                </a:cubicBezTo>
                <a:cubicBezTo>
                  <a:pt x="547126" y="653024"/>
                  <a:pt x="452375" y="721613"/>
                  <a:pt x="514350" y="628650"/>
                </a:cubicBezTo>
                <a:cubicBezTo>
                  <a:pt x="568945" y="546758"/>
                  <a:pt x="503490" y="650370"/>
                  <a:pt x="542925" y="571500"/>
                </a:cubicBezTo>
                <a:cubicBezTo>
                  <a:pt x="548045" y="561261"/>
                  <a:pt x="556855" y="553164"/>
                  <a:pt x="561975" y="542925"/>
                </a:cubicBezTo>
                <a:cubicBezTo>
                  <a:pt x="566465" y="533945"/>
                  <a:pt x="567010" y="523330"/>
                  <a:pt x="571500" y="514350"/>
                </a:cubicBezTo>
                <a:cubicBezTo>
                  <a:pt x="576620" y="504111"/>
                  <a:pt x="585430" y="496014"/>
                  <a:pt x="590550" y="485775"/>
                </a:cubicBezTo>
                <a:cubicBezTo>
                  <a:pt x="609086" y="448704"/>
                  <a:pt x="591289" y="461826"/>
                  <a:pt x="609600" y="419100"/>
                </a:cubicBezTo>
                <a:cubicBezTo>
                  <a:pt x="614109" y="408578"/>
                  <a:pt x="620555" y="398620"/>
                  <a:pt x="628650" y="390525"/>
                </a:cubicBezTo>
                <a:cubicBezTo>
                  <a:pt x="636745" y="382430"/>
                  <a:pt x="647700" y="377825"/>
                  <a:pt x="657225" y="371475"/>
                </a:cubicBezTo>
                <a:cubicBezTo>
                  <a:pt x="674019" y="421858"/>
                  <a:pt x="662864" y="383441"/>
                  <a:pt x="676275" y="457200"/>
                </a:cubicBezTo>
                <a:cubicBezTo>
                  <a:pt x="702900" y="603638"/>
                  <a:pt x="667258" y="393570"/>
                  <a:pt x="695325" y="561975"/>
                </a:cubicBezTo>
                <a:cubicBezTo>
                  <a:pt x="692150" y="609600"/>
                  <a:pt x="691071" y="657411"/>
                  <a:pt x="685800" y="704850"/>
                </a:cubicBezTo>
                <a:cubicBezTo>
                  <a:pt x="680807" y="749786"/>
                  <a:pt x="654159" y="727293"/>
                  <a:pt x="685800" y="790575"/>
                </a:cubicBezTo>
                <a:cubicBezTo>
                  <a:pt x="690920" y="800814"/>
                  <a:pt x="704850" y="803275"/>
                  <a:pt x="714375" y="809625"/>
                </a:cubicBezTo>
                <a:cubicBezTo>
                  <a:pt x="762000" y="803275"/>
                  <a:pt x="811391" y="804906"/>
                  <a:pt x="857250" y="790575"/>
                </a:cubicBezTo>
                <a:cubicBezTo>
                  <a:pt x="866833" y="787580"/>
                  <a:pt x="864340" y="771740"/>
                  <a:pt x="866775" y="762000"/>
                </a:cubicBezTo>
                <a:cubicBezTo>
                  <a:pt x="870702" y="746294"/>
                  <a:pt x="872040" y="729994"/>
                  <a:pt x="876300" y="714375"/>
                </a:cubicBezTo>
                <a:cubicBezTo>
                  <a:pt x="881584" y="695002"/>
                  <a:pt x="890480" y="676706"/>
                  <a:pt x="895350" y="657225"/>
                </a:cubicBezTo>
                <a:cubicBezTo>
                  <a:pt x="898525" y="644525"/>
                  <a:pt x="901113" y="631664"/>
                  <a:pt x="904875" y="619125"/>
                </a:cubicBezTo>
                <a:cubicBezTo>
                  <a:pt x="910645" y="599891"/>
                  <a:pt x="909726" y="576174"/>
                  <a:pt x="923925" y="561975"/>
                </a:cubicBezTo>
                <a:cubicBezTo>
                  <a:pt x="960595" y="525305"/>
                  <a:pt x="941292" y="540872"/>
                  <a:pt x="981075" y="514350"/>
                </a:cubicBezTo>
                <a:cubicBezTo>
                  <a:pt x="990600" y="523875"/>
                  <a:pt x="1003108" y="531150"/>
                  <a:pt x="1009650" y="542925"/>
                </a:cubicBezTo>
                <a:cubicBezTo>
                  <a:pt x="1019402" y="560478"/>
                  <a:pt x="1022350" y="581025"/>
                  <a:pt x="1028700" y="600075"/>
                </a:cubicBezTo>
                <a:cubicBezTo>
                  <a:pt x="1031875" y="609600"/>
                  <a:pt x="1032656" y="620296"/>
                  <a:pt x="1038225" y="628650"/>
                </a:cubicBezTo>
                <a:cubicBezTo>
                  <a:pt x="1106298" y="730760"/>
                  <a:pt x="1000287" y="575791"/>
                  <a:pt x="1085850" y="685800"/>
                </a:cubicBezTo>
                <a:cubicBezTo>
                  <a:pt x="1122218" y="732559"/>
                  <a:pt x="1108941" y="740208"/>
                  <a:pt x="1152525" y="762000"/>
                </a:cubicBezTo>
                <a:cubicBezTo>
                  <a:pt x="1161505" y="766490"/>
                  <a:pt x="1171575" y="768350"/>
                  <a:pt x="1181100" y="771525"/>
                </a:cubicBezTo>
                <a:cubicBezTo>
                  <a:pt x="1209675" y="768350"/>
                  <a:pt x="1254928" y="788174"/>
                  <a:pt x="1266825" y="762000"/>
                </a:cubicBezTo>
                <a:cubicBezTo>
                  <a:pt x="1377568" y="518366"/>
                  <a:pt x="1197872" y="588134"/>
                  <a:pt x="1304925" y="552450"/>
                </a:cubicBezTo>
                <a:cubicBezTo>
                  <a:pt x="1333500" y="555625"/>
                  <a:pt x="1362758" y="555002"/>
                  <a:pt x="1390650" y="561975"/>
                </a:cubicBezTo>
                <a:cubicBezTo>
                  <a:pt x="1401756" y="564751"/>
                  <a:pt x="1408986" y="575905"/>
                  <a:pt x="1419225" y="581025"/>
                </a:cubicBezTo>
                <a:cubicBezTo>
                  <a:pt x="1428205" y="585515"/>
                  <a:pt x="1438275" y="587375"/>
                  <a:pt x="1447800" y="590550"/>
                </a:cubicBezTo>
                <a:lnTo>
                  <a:pt x="1504950" y="676275"/>
                </a:lnTo>
                <a:cubicBezTo>
                  <a:pt x="1511300" y="685800"/>
                  <a:pt x="1513140" y="701230"/>
                  <a:pt x="1524000" y="704850"/>
                </a:cubicBezTo>
                <a:lnTo>
                  <a:pt x="1581150" y="723900"/>
                </a:lnTo>
                <a:cubicBezTo>
                  <a:pt x="1603375" y="720725"/>
                  <a:pt x="1630104" y="728158"/>
                  <a:pt x="1647825" y="714375"/>
                </a:cubicBezTo>
                <a:cubicBezTo>
                  <a:pt x="1663676" y="702047"/>
                  <a:pt x="1666875" y="657225"/>
                  <a:pt x="1666875" y="657225"/>
                </a:cubicBezTo>
                <a:cubicBezTo>
                  <a:pt x="1687541" y="491894"/>
                  <a:pt x="1661519" y="659598"/>
                  <a:pt x="1695450" y="523875"/>
                </a:cubicBezTo>
                <a:cubicBezTo>
                  <a:pt x="1698625" y="511175"/>
                  <a:pt x="1697713" y="496667"/>
                  <a:pt x="1704975" y="485775"/>
                </a:cubicBezTo>
                <a:cubicBezTo>
                  <a:pt x="1711325" y="476250"/>
                  <a:pt x="1724025" y="473075"/>
                  <a:pt x="1733550" y="466725"/>
                </a:cubicBezTo>
                <a:cubicBezTo>
                  <a:pt x="1762125" y="473075"/>
                  <a:pt x="1791297" y="477167"/>
                  <a:pt x="1819275" y="485775"/>
                </a:cubicBezTo>
                <a:cubicBezTo>
                  <a:pt x="1880479" y="504607"/>
                  <a:pt x="1833917" y="512644"/>
                  <a:pt x="1885950" y="495300"/>
                </a:cubicBezTo>
                <a:cubicBezTo>
                  <a:pt x="1892300" y="476250"/>
                  <a:pt x="1906540" y="458171"/>
                  <a:pt x="1905000" y="438150"/>
                </a:cubicBezTo>
                <a:cubicBezTo>
                  <a:pt x="1901825" y="396875"/>
                  <a:pt x="1907823" y="353838"/>
                  <a:pt x="1895475" y="314325"/>
                </a:cubicBezTo>
                <a:cubicBezTo>
                  <a:pt x="1890740" y="299173"/>
                  <a:pt x="1870293" y="294977"/>
                  <a:pt x="1857375" y="285750"/>
                </a:cubicBezTo>
                <a:cubicBezTo>
                  <a:pt x="1810028" y="251931"/>
                  <a:pt x="1844651" y="275425"/>
                  <a:pt x="1771650" y="257175"/>
                </a:cubicBezTo>
                <a:cubicBezTo>
                  <a:pt x="1717242" y="243573"/>
                  <a:pt x="1723454" y="244094"/>
                  <a:pt x="1685925" y="219075"/>
                </a:cubicBezTo>
                <a:cubicBezTo>
                  <a:pt x="1682750" y="206375"/>
                  <a:pt x="1681557" y="193007"/>
                  <a:pt x="1676400" y="180975"/>
                </a:cubicBezTo>
                <a:cubicBezTo>
                  <a:pt x="1648913" y="116838"/>
                  <a:pt x="1616236" y="155563"/>
                  <a:pt x="1533525" y="161925"/>
                </a:cubicBezTo>
                <a:cubicBezTo>
                  <a:pt x="1503336" y="207208"/>
                  <a:pt x="1518095" y="179640"/>
                  <a:pt x="1495425" y="247650"/>
                </a:cubicBezTo>
                <a:lnTo>
                  <a:pt x="1485900" y="276225"/>
                </a:lnTo>
                <a:cubicBezTo>
                  <a:pt x="1473200" y="273050"/>
                  <a:pt x="1458692" y="273962"/>
                  <a:pt x="1447800" y="266700"/>
                </a:cubicBezTo>
                <a:cubicBezTo>
                  <a:pt x="1438275" y="260350"/>
                  <a:pt x="1433399" y="248586"/>
                  <a:pt x="1428750" y="238125"/>
                </a:cubicBezTo>
                <a:cubicBezTo>
                  <a:pt x="1420595" y="219775"/>
                  <a:pt x="1413001" y="200782"/>
                  <a:pt x="1409700" y="180975"/>
                </a:cubicBezTo>
                <a:cubicBezTo>
                  <a:pt x="1406525" y="161925"/>
                  <a:pt x="1409757" y="140593"/>
                  <a:pt x="1400175" y="123825"/>
                </a:cubicBezTo>
                <a:cubicBezTo>
                  <a:pt x="1395194" y="115108"/>
                  <a:pt x="1381125" y="117475"/>
                  <a:pt x="1371600" y="114300"/>
                </a:cubicBezTo>
                <a:cubicBezTo>
                  <a:pt x="1365250" y="104775"/>
                  <a:pt x="1359879" y="94519"/>
                  <a:pt x="1352550" y="85725"/>
                </a:cubicBezTo>
                <a:cubicBezTo>
                  <a:pt x="1305607" y="29394"/>
                  <a:pt x="1312802" y="58081"/>
                  <a:pt x="1209675" y="66675"/>
                </a:cubicBezTo>
                <a:cubicBezTo>
                  <a:pt x="1203325" y="76200"/>
                  <a:pt x="1198720" y="87155"/>
                  <a:pt x="1190625" y="95250"/>
                </a:cubicBezTo>
                <a:cubicBezTo>
                  <a:pt x="1127125" y="158750"/>
                  <a:pt x="1193800" y="66675"/>
                  <a:pt x="1143000" y="142875"/>
                </a:cubicBezTo>
                <a:cubicBezTo>
                  <a:pt x="1136650" y="168275"/>
                  <a:pt x="1132229" y="194237"/>
                  <a:pt x="1123950" y="219075"/>
                </a:cubicBezTo>
                <a:cubicBezTo>
                  <a:pt x="1120775" y="228600"/>
                  <a:pt x="1118915" y="238670"/>
                  <a:pt x="1114425" y="247650"/>
                </a:cubicBezTo>
                <a:cubicBezTo>
                  <a:pt x="1109305" y="257889"/>
                  <a:pt x="1101725" y="266700"/>
                  <a:pt x="1095375" y="276225"/>
                </a:cubicBezTo>
                <a:cubicBezTo>
                  <a:pt x="1036646" y="197919"/>
                  <a:pt x="1077521" y="266747"/>
                  <a:pt x="1057275" y="104775"/>
                </a:cubicBezTo>
                <a:cubicBezTo>
                  <a:pt x="1044481" y="2421"/>
                  <a:pt x="1066392" y="18914"/>
                  <a:pt x="1009650" y="0"/>
                </a:cubicBezTo>
                <a:cubicBezTo>
                  <a:pt x="971550" y="3175"/>
                  <a:pt x="930377" y="-5799"/>
                  <a:pt x="895350" y="9525"/>
                </a:cubicBezTo>
                <a:cubicBezTo>
                  <a:pt x="862711" y="23805"/>
                  <a:pt x="859653" y="67418"/>
                  <a:pt x="847725" y="95250"/>
                </a:cubicBezTo>
                <a:cubicBezTo>
                  <a:pt x="797628" y="212142"/>
                  <a:pt x="857454" y="66266"/>
                  <a:pt x="809625" y="161925"/>
                </a:cubicBezTo>
                <a:cubicBezTo>
                  <a:pt x="805135" y="170905"/>
                  <a:pt x="804590" y="181520"/>
                  <a:pt x="800100" y="190500"/>
                </a:cubicBezTo>
                <a:cubicBezTo>
                  <a:pt x="763171" y="264358"/>
                  <a:pt x="795466" y="175826"/>
                  <a:pt x="771525" y="247650"/>
                </a:cubicBezTo>
                <a:cubicBezTo>
                  <a:pt x="765175" y="238125"/>
                  <a:pt x="757595" y="229314"/>
                  <a:pt x="752475" y="219075"/>
                </a:cubicBezTo>
                <a:cubicBezTo>
                  <a:pt x="730826" y="175777"/>
                  <a:pt x="734930" y="78220"/>
                  <a:pt x="733425" y="57150"/>
                </a:cubicBezTo>
                <a:cubicBezTo>
                  <a:pt x="714375" y="60325"/>
                  <a:pt x="694773" y="61126"/>
                  <a:pt x="676275" y="66675"/>
                </a:cubicBezTo>
                <a:cubicBezTo>
                  <a:pt x="663257" y="70580"/>
                  <a:pt x="621512" y="94186"/>
                  <a:pt x="609600" y="104775"/>
                </a:cubicBezTo>
                <a:cubicBezTo>
                  <a:pt x="589464" y="122673"/>
                  <a:pt x="567394" y="139509"/>
                  <a:pt x="552450" y="161925"/>
                </a:cubicBezTo>
                <a:cubicBezTo>
                  <a:pt x="546100" y="171450"/>
                  <a:pt x="542339" y="183349"/>
                  <a:pt x="533400" y="190500"/>
                </a:cubicBezTo>
                <a:cubicBezTo>
                  <a:pt x="525560" y="196772"/>
                  <a:pt x="514350" y="196850"/>
                  <a:pt x="504825" y="200025"/>
                </a:cubicBezTo>
                <a:cubicBezTo>
                  <a:pt x="488950" y="196850"/>
                  <a:pt x="468648" y="201948"/>
                  <a:pt x="457200" y="190500"/>
                </a:cubicBezTo>
                <a:cubicBezTo>
                  <a:pt x="443001" y="176301"/>
                  <a:pt x="444500" y="152400"/>
                  <a:pt x="438150" y="133350"/>
                </a:cubicBezTo>
                <a:cubicBezTo>
                  <a:pt x="424485" y="92356"/>
                  <a:pt x="431060" y="114515"/>
                  <a:pt x="419100" y="66675"/>
                </a:cubicBezTo>
                <a:cubicBezTo>
                  <a:pt x="329490" y="82968"/>
                  <a:pt x="335338" y="67584"/>
                  <a:pt x="285750" y="104775"/>
                </a:cubicBezTo>
                <a:cubicBezTo>
                  <a:pt x="282158" y="107469"/>
                  <a:pt x="295275" y="84138"/>
                  <a:pt x="276225" y="85725"/>
                </a:cubicBezTo>
                <a:close/>
              </a:path>
            </a:pathLst>
          </a:cu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椭圆 71"/>
          <p:cNvSpPr/>
          <p:nvPr/>
        </p:nvSpPr>
        <p:spPr>
          <a:xfrm>
            <a:off x="1332000" y="5753160"/>
            <a:ext cx="2303280" cy="1060560"/>
          </a:xfrm>
          <a:prstGeom prst="ellips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TextBox 75"/>
          <p:cNvSpPr/>
          <p:nvPr/>
        </p:nvSpPr>
        <p:spPr>
          <a:xfrm>
            <a:off x="1850040" y="6053040"/>
            <a:ext cx="126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A Cyc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矩形 292"/>
          <p:cNvSpPr/>
          <p:nvPr/>
        </p:nvSpPr>
        <p:spPr>
          <a:xfrm rot="16200000">
            <a:off x="1154880" y="873720"/>
            <a:ext cx="101520" cy="106560"/>
          </a:xfrm>
          <a:prstGeom prst="rect">
            <a:avLst/>
          </a:prstGeom>
          <a:solidFill>
            <a:srgbClr val="ff6699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矩形 294"/>
          <p:cNvSpPr/>
          <p:nvPr/>
        </p:nvSpPr>
        <p:spPr>
          <a:xfrm>
            <a:off x="1297080" y="873000"/>
            <a:ext cx="101520" cy="108000"/>
          </a:xfrm>
          <a:prstGeom prst="rect">
            <a:avLst/>
          </a:prstGeom>
          <a:solidFill>
            <a:srgbClr val="009900"/>
          </a:solidFill>
          <a:ln w="648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Box 295"/>
          <p:cNvSpPr/>
          <p:nvPr/>
        </p:nvSpPr>
        <p:spPr>
          <a:xfrm>
            <a:off x="5344200" y="1989000"/>
            <a:ext cx="1668240" cy="307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-D-Fructose-1,6-2P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248" name="直接箭头连接符 314"/>
          <p:cNvCxnSpPr/>
          <p:nvPr/>
        </p:nvCxnSpPr>
        <p:spPr>
          <a:xfrm>
            <a:off x="6162480" y="1644120"/>
            <a:ext cx="1080" cy="291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grpSp>
        <p:nvGrpSpPr>
          <p:cNvPr id="249" name="组合 84"/>
          <p:cNvGrpSpPr/>
          <p:nvPr/>
        </p:nvGrpSpPr>
        <p:grpSpPr>
          <a:xfrm>
            <a:off x="6291360" y="1679400"/>
            <a:ext cx="873000" cy="266760"/>
            <a:chOff x="6291360" y="1679400"/>
            <a:chExt cx="873000" cy="266760"/>
          </a:xfrm>
        </p:grpSpPr>
        <p:sp>
          <p:nvSpPr>
            <p:cNvPr id="250" name="矩形 315"/>
            <p:cNvSpPr/>
            <p:nvPr/>
          </p:nvSpPr>
          <p:spPr>
            <a:xfrm rot="16200000">
              <a:off x="6294240" y="1679400"/>
              <a:ext cx="100800" cy="106920"/>
            </a:xfrm>
            <a:prstGeom prst="rect">
              <a:avLst/>
            </a:prstGeom>
            <a:solidFill>
              <a:srgbClr val="ff6699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矩形 321"/>
            <p:cNvSpPr/>
            <p:nvPr/>
          </p:nvSpPr>
          <p:spPr>
            <a:xfrm rot="16200000">
              <a:off x="6451200" y="1679400"/>
              <a:ext cx="10080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矩形 322"/>
            <p:cNvSpPr/>
            <p:nvPr/>
          </p:nvSpPr>
          <p:spPr>
            <a:xfrm rot="16200000">
              <a:off x="6608520" y="1679400"/>
              <a:ext cx="100800" cy="106920"/>
            </a:xfrm>
            <a:prstGeom prst="rect">
              <a:avLst/>
            </a:prstGeom>
            <a:solidFill>
              <a:srgbClr val="cc0099"/>
            </a:solidFill>
            <a:ln w="324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矩形 323"/>
            <p:cNvSpPr/>
            <p:nvPr/>
          </p:nvSpPr>
          <p:spPr>
            <a:xfrm>
              <a:off x="6762960" y="1679400"/>
              <a:ext cx="100440" cy="10764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矩形 324"/>
            <p:cNvSpPr/>
            <p:nvPr/>
          </p:nvSpPr>
          <p:spPr>
            <a:xfrm>
              <a:off x="6913440" y="1679400"/>
              <a:ext cx="100440" cy="10764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矩形 325"/>
            <p:cNvSpPr/>
            <p:nvPr/>
          </p:nvSpPr>
          <p:spPr>
            <a:xfrm>
              <a:off x="7063920" y="1679400"/>
              <a:ext cx="100440" cy="10764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矩形 326"/>
            <p:cNvSpPr/>
            <p:nvPr/>
          </p:nvSpPr>
          <p:spPr>
            <a:xfrm>
              <a:off x="6291360" y="1838520"/>
              <a:ext cx="100440" cy="10764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矩形 327"/>
            <p:cNvSpPr/>
            <p:nvPr/>
          </p:nvSpPr>
          <p:spPr>
            <a:xfrm>
              <a:off x="6443640" y="1838520"/>
              <a:ext cx="100440" cy="10764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矩形 328"/>
            <p:cNvSpPr/>
            <p:nvPr/>
          </p:nvSpPr>
          <p:spPr>
            <a:xfrm>
              <a:off x="6596280" y="1838520"/>
              <a:ext cx="100440" cy="10764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矩形 329"/>
            <p:cNvSpPr/>
            <p:nvPr/>
          </p:nvSpPr>
          <p:spPr>
            <a:xfrm>
              <a:off x="6748920" y="1838520"/>
              <a:ext cx="100440" cy="107640"/>
            </a:xfrm>
            <a:prstGeom prst="rect">
              <a:avLst/>
            </a:prstGeom>
            <a:solidFill>
              <a:srgbClr val="ff0000"/>
            </a:solidFill>
            <a:ln w="6480">
              <a:solidFill>
                <a:srgbClr val="948a54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cxnSp>
        <p:nvCxnSpPr>
          <p:cNvPr id="260" name="直接箭头连接符 330"/>
          <p:cNvCxnSpPr/>
          <p:nvPr/>
        </p:nvCxnSpPr>
        <p:spPr>
          <a:xfrm>
            <a:off x="6162480" y="2900160"/>
            <a:ext cx="1080" cy="292680"/>
          </a:xfrm>
          <a:prstGeom prst="straightConnector1">
            <a:avLst/>
          </a:prstGeom>
          <a:ln w="9360">
            <a:solidFill>
              <a:srgbClr val="000000"/>
            </a:solidFill>
            <a:prstDash val="dashDot"/>
            <a:miter/>
            <a:tailEnd len="med" type="arrow" w="med"/>
          </a:ln>
        </p:spPr>
      </p:cxnSp>
      <p:grpSp>
        <p:nvGrpSpPr>
          <p:cNvPr id="261" name="组合 2"/>
          <p:cNvGrpSpPr/>
          <p:nvPr/>
        </p:nvGrpSpPr>
        <p:grpSpPr>
          <a:xfrm>
            <a:off x="105120" y="2781360"/>
            <a:ext cx="2127960" cy="1050840"/>
            <a:chOff x="105120" y="2781360"/>
            <a:chExt cx="2127960" cy="1050840"/>
          </a:xfrm>
        </p:grpSpPr>
        <p:grpSp>
          <p:nvGrpSpPr>
            <p:cNvPr id="262" name="组合 70"/>
            <p:cNvGrpSpPr/>
            <p:nvPr/>
          </p:nvGrpSpPr>
          <p:grpSpPr>
            <a:xfrm>
              <a:off x="292680" y="3075840"/>
              <a:ext cx="1940400" cy="756360"/>
              <a:chOff x="292680" y="3075840"/>
              <a:chExt cx="1940400" cy="756360"/>
            </a:xfrm>
          </p:grpSpPr>
          <p:sp>
            <p:nvSpPr>
              <p:cNvPr id="263" name="矩形 134"/>
              <p:cNvSpPr/>
              <p:nvPr/>
            </p:nvSpPr>
            <p:spPr>
              <a:xfrm>
                <a:off x="1281240" y="3169440"/>
                <a:ext cx="100440" cy="107280"/>
              </a:xfrm>
              <a:prstGeom prst="rect">
                <a:avLst/>
              </a:prstGeom>
              <a:solidFill>
                <a:srgbClr val="ff66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4" name="矩形 135"/>
              <p:cNvSpPr/>
              <p:nvPr/>
            </p:nvSpPr>
            <p:spPr>
              <a:xfrm>
                <a:off x="1284480" y="3396960"/>
                <a:ext cx="100440" cy="107280"/>
              </a:xfrm>
              <a:prstGeom prst="rect">
                <a:avLst/>
              </a:prstGeom>
              <a:solidFill>
                <a:srgbClr val="cc009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5" name="矩形 136"/>
              <p:cNvSpPr/>
              <p:nvPr/>
            </p:nvSpPr>
            <p:spPr>
              <a:xfrm>
                <a:off x="1284480" y="3613680"/>
                <a:ext cx="100440" cy="107280"/>
              </a:xfrm>
              <a:prstGeom prst="rect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6" name="TextBox 137"/>
              <p:cNvSpPr/>
              <p:nvPr/>
            </p:nvSpPr>
            <p:spPr>
              <a:xfrm>
                <a:off x="1463760" y="3075840"/>
                <a:ext cx="704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 h Vs 0 h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7" name="TextBox 138"/>
              <p:cNvSpPr/>
              <p:nvPr/>
            </p:nvSpPr>
            <p:spPr>
              <a:xfrm>
                <a:off x="1469160" y="3322080"/>
                <a:ext cx="704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 h Vs 0 h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8" name="TextBox 139"/>
              <p:cNvSpPr/>
              <p:nvPr/>
            </p:nvSpPr>
            <p:spPr>
              <a:xfrm>
                <a:off x="1464120" y="3543840"/>
                <a:ext cx="768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4 h Vs 0 h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69" name="TextBox 140"/>
              <p:cNvSpPr/>
              <p:nvPr/>
            </p:nvSpPr>
            <p:spPr>
              <a:xfrm>
                <a:off x="399600" y="3117600"/>
                <a:ext cx="704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 h Vs 0 h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0" name="TextBox 141"/>
              <p:cNvSpPr/>
              <p:nvPr/>
            </p:nvSpPr>
            <p:spPr>
              <a:xfrm>
                <a:off x="405000" y="3364200"/>
                <a:ext cx="704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 h Vs 0 h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1" name="TextBox 142"/>
              <p:cNvSpPr/>
              <p:nvPr/>
            </p:nvSpPr>
            <p:spPr>
              <a:xfrm>
                <a:off x="399960" y="3585960"/>
                <a:ext cx="7689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4 h Vs 0 h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2" name="矩形 143"/>
              <p:cNvSpPr/>
              <p:nvPr/>
            </p:nvSpPr>
            <p:spPr>
              <a:xfrm>
                <a:off x="292680" y="3169440"/>
                <a:ext cx="100440" cy="107280"/>
              </a:xfrm>
              <a:prstGeom prst="rect">
                <a:avLst/>
              </a:prstGeom>
              <a:solidFill>
                <a:srgbClr val="9bbb59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3" name="矩形 144"/>
              <p:cNvSpPr/>
              <p:nvPr/>
            </p:nvSpPr>
            <p:spPr>
              <a:xfrm>
                <a:off x="295920" y="3396960"/>
                <a:ext cx="100440" cy="10728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74" name="矩形 145"/>
              <p:cNvSpPr/>
              <p:nvPr/>
            </p:nvSpPr>
            <p:spPr>
              <a:xfrm>
                <a:off x="295920" y="3613680"/>
                <a:ext cx="100440" cy="107280"/>
              </a:xfrm>
              <a:prstGeom prst="rect">
                <a:avLst/>
              </a:prstGeom>
              <a:solidFill>
                <a:srgbClr val="0099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75" name="文本框 1"/>
            <p:cNvSpPr/>
            <p:nvPr/>
          </p:nvSpPr>
          <p:spPr>
            <a:xfrm>
              <a:off x="105120" y="2800080"/>
              <a:ext cx="1168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own-regul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文本框 233"/>
            <p:cNvSpPr/>
            <p:nvPr/>
          </p:nvSpPr>
          <p:spPr>
            <a:xfrm>
              <a:off x="1207800" y="2781360"/>
              <a:ext cx="98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Up-regulated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21T02:42:58Z</dcterms:created>
  <dc:creator>ZhangYun</dc:creator>
  <dc:description/>
  <dc:language>en-US</dc:language>
  <cp:lastModifiedBy>张云</cp:lastModifiedBy>
  <dcterms:modified xsi:type="dcterms:W3CDTF">2017-03-09T06:25:59Z</dcterms:modified>
  <cp:revision>41</cp:revision>
  <dc:subject/>
  <dc:title>PowerPoint 演示文稿</dc:title>
</cp:coreProperties>
</file>